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6" r:id="rId5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Keine Formatvorlage, Tabellenraster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Keine Formatvorlage, kein Raster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06" d="100"/>
          <a:sy n="106" d="100"/>
        </p:scale>
        <p:origin x="696" y="3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10" Type="http://schemas.microsoft.com/office/2016/11/relationships/changesInfo" Target="changesInfos/changesInfo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Buttgereit, Thomas" userId="7fdb69dc-7db8-4d3d-bfe3-24e8a0f5cc6e" providerId="ADAL" clId="{6CC62960-5881-46EA-9138-22487FC8AAE3}"/>
    <pc:docChg chg="undo custSel modSld">
      <pc:chgData name="Buttgereit, Thomas" userId="7fdb69dc-7db8-4d3d-bfe3-24e8a0f5cc6e" providerId="ADAL" clId="{6CC62960-5881-46EA-9138-22487FC8AAE3}" dt="2026-01-12T13:39:16.671" v="113" actId="1076"/>
      <pc:docMkLst>
        <pc:docMk/>
      </pc:docMkLst>
      <pc:sldChg chg="addSp delSp modSp">
        <pc:chgData name="Buttgereit, Thomas" userId="7fdb69dc-7db8-4d3d-bfe3-24e8a0f5cc6e" providerId="ADAL" clId="{6CC62960-5881-46EA-9138-22487FC8AAE3}" dt="2026-01-12T13:39:16.671" v="113" actId="1076"/>
        <pc:sldMkLst>
          <pc:docMk/>
          <pc:sldMk cId="4278982241" sldId="256"/>
        </pc:sldMkLst>
        <pc:graphicFrameChg chg="mod modGraphic">
          <ac:chgData name="Buttgereit, Thomas" userId="7fdb69dc-7db8-4d3d-bfe3-24e8a0f5cc6e" providerId="ADAL" clId="{6CC62960-5881-46EA-9138-22487FC8AAE3}" dt="2026-01-12T13:39:16.671" v="113" actId="1076"/>
          <ac:graphicFrameMkLst>
            <pc:docMk/>
            <pc:sldMk cId="4278982241" sldId="256"/>
            <ac:graphicFrameMk id="4" creationId="{4944CCFA-BB97-43F0-A3A6-DAD025C8BBB5}"/>
          </ac:graphicFrameMkLst>
        </pc:graphicFrameChg>
        <pc:graphicFrameChg chg="add del mod modGraphic">
          <ac:chgData name="Buttgereit, Thomas" userId="7fdb69dc-7db8-4d3d-bfe3-24e8a0f5cc6e" providerId="ADAL" clId="{6CC62960-5881-46EA-9138-22487FC8AAE3}" dt="2026-01-06T15:38:15.324" v="24" actId="478"/>
          <ac:graphicFrameMkLst>
            <pc:docMk/>
            <pc:sldMk cId="4278982241" sldId="256"/>
            <ac:graphicFrameMk id="5" creationId="{EBEF44D7-30B3-4963-9E6C-680CEF30D99C}"/>
          </ac:graphicFrameMkLst>
        </pc:graphicFrameChg>
      </pc:sldChg>
    </pc:docChg>
  </pc:docChgLst>
  <pc:docChgLst>
    <pc:chgData name="Buttgereit, Thomas" userId="7fdb69dc-7db8-4d3d-bfe3-24e8a0f5cc6e" providerId="ADAL" clId="{3DD78422-395E-0C45-9239-B9AADBCC7605}"/>
    <pc:docChg chg="custSel modSld">
      <pc:chgData name="Buttgereit, Thomas" userId="7fdb69dc-7db8-4d3d-bfe3-24e8a0f5cc6e" providerId="ADAL" clId="{3DD78422-395E-0C45-9239-B9AADBCC7605}" dt="2026-01-14T18:34:56.405" v="6" actId="207"/>
      <pc:docMkLst>
        <pc:docMk/>
      </pc:docMkLst>
      <pc:sldChg chg="modSp mod">
        <pc:chgData name="Buttgereit, Thomas" userId="7fdb69dc-7db8-4d3d-bfe3-24e8a0f5cc6e" providerId="ADAL" clId="{3DD78422-395E-0C45-9239-B9AADBCC7605}" dt="2026-01-14T18:34:56.405" v="6" actId="207"/>
        <pc:sldMkLst>
          <pc:docMk/>
          <pc:sldMk cId="4278982241" sldId="256"/>
        </pc:sldMkLst>
        <pc:graphicFrameChg chg="modGraphic">
          <ac:chgData name="Buttgereit, Thomas" userId="7fdb69dc-7db8-4d3d-bfe3-24e8a0f5cc6e" providerId="ADAL" clId="{3DD78422-395E-0C45-9239-B9AADBCC7605}" dt="2026-01-14T18:34:56.405" v="6" actId="207"/>
          <ac:graphicFrameMkLst>
            <pc:docMk/>
            <pc:sldMk cId="4278982241" sldId="256"/>
            <ac:graphicFrameMk id="4" creationId="{4944CCFA-BB97-43F0-A3A6-DAD025C8BBB5}"/>
          </ac:graphicFrameMkLst>
        </pc:graphicFrame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39A1196-901A-4627-A903-2611895A2BE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7DE11527-EC02-4D2B-8EF1-78E0BDDF100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D30F6128-C0BE-4440-B587-251EAF9AD8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F20D84-A121-4D68-964B-4CEB1B9137B6}" type="datetimeFigureOut">
              <a:rPr lang="de-DE" smtClean="0"/>
              <a:t>14.01.26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AF356087-4074-43D8-AE88-4430F1EDF6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925BF908-7E16-4ADB-975A-91DDC00BB3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ADA1EA-E962-4660-8069-EE334EA8302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327918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58E1018-C361-4663-9EE4-E7C2071AC4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B61C25F1-3AB3-4935-BE6C-53F593B9931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6CB0070E-1BAB-4F66-909D-B4774FE524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F20D84-A121-4D68-964B-4CEB1B9137B6}" type="datetimeFigureOut">
              <a:rPr lang="de-DE" smtClean="0"/>
              <a:t>14.01.26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253C9DB8-ACE7-4066-AA66-5785DFF6EC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E6531AF8-7599-415F-81D0-B0DE57B3E5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ADA1EA-E962-4660-8069-EE334EA8302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670889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969B6363-14BA-472E-A954-A2681BB85ED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7B49422F-962C-46D6-8032-9FCE9B834EB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FA00532E-F66D-4703-9686-35E44B22A5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F20D84-A121-4D68-964B-4CEB1B9137B6}" type="datetimeFigureOut">
              <a:rPr lang="de-DE" smtClean="0"/>
              <a:t>14.01.26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0C661EDD-294C-4972-8870-19D462D07A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217716DA-BCCB-4DA5-A2B3-C46F0405CD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ADA1EA-E962-4660-8069-EE334EA8302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118928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E18467E7-C0C3-4357-856D-1070BE4F45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09703D27-CAA5-4AE8-9626-82FB1319A2E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3211F31B-C8F9-4EBA-82F1-1FF798D7C2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F20D84-A121-4D68-964B-4CEB1B9137B6}" type="datetimeFigureOut">
              <a:rPr lang="de-DE" smtClean="0"/>
              <a:t>14.01.26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BDB70B1A-AA2B-4145-9F45-F6F2C7AF63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50DB8107-AE54-4B51-9FCE-4849243597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ADA1EA-E962-4660-8069-EE334EA8302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975775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D3D0D2B-F8E6-4069-B03F-258054701FE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707038A2-5934-48B8-A719-56F9DC11B26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6008314E-08BC-4E96-91EA-8B4698BD14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F20D84-A121-4D68-964B-4CEB1B9137B6}" type="datetimeFigureOut">
              <a:rPr lang="de-DE" smtClean="0"/>
              <a:t>14.01.26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29563F0B-62E4-45BE-A048-BAC6024FDD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A78454B6-4398-4C23-B30E-624DF37111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ADA1EA-E962-4660-8069-EE334EA8302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178653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E414F44A-8CF4-4F8D-B541-67E1F64576B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01C5310E-E950-450A-8EE4-A70690EF8E8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017D116A-CC19-4390-B5AE-8C26D35EF39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00AE250C-665B-47CF-BA78-F2C0DAA9BF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F20D84-A121-4D68-964B-4CEB1B9137B6}" type="datetimeFigureOut">
              <a:rPr lang="de-DE" smtClean="0"/>
              <a:t>14.01.26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524A5E7B-EB03-44F5-ACF4-D83EAD3934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773E6745-469B-4608-8193-79D862A5D0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ADA1EA-E962-4660-8069-EE334EA8302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937229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2FC29CF-62F1-4212-AECD-40FAA1774A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F07161F4-BB0D-437D-AA5D-8F34364529F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ABB3CFBE-9C54-4480-B510-7B3B0E4A9CE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52E308DF-62AD-46E1-9381-222843B073C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DCE65EC3-C8D5-41E3-ABC3-823B40027BA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721AE9BE-0D1C-40C3-8D09-F79B3392EF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F20D84-A121-4D68-964B-4CEB1B9137B6}" type="datetimeFigureOut">
              <a:rPr lang="de-DE" smtClean="0"/>
              <a:t>14.01.26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3BB83B64-3AE9-4F4A-B0B8-095C89496E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C832FC8C-BB81-4B42-A2EF-2F8708E263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ADA1EA-E962-4660-8069-EE334EA8302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514209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598CC06-B65C-419D-9FA3-B6ED5742C8F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72D79093-4BFD-48AC-A0FE-96D0D50BF4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F20D84-A121-4D68-964B-4CEB1B9137B6}" type="datetimeFigureOut">
              <a:rPr lang="de-DE" smtClean="0"/>
              <a:t>14.01.26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0F1ED846-8C17-4BDA-84F6-1C908FA08A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F602F5D2-2D7F-4C4E-9B19-2B114664BD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ADA1EA-E962-4660-8069-EE334EA8302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777642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9A34F2E4-C8BC-4C48-B84E-5F04360558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F20D84-A121-4D68-964B-4CEB1B9137B6}" type="datetimeFigureOut">
              <a:rPr lang="de-DE" smtClean="0"/>
              <a:t>14.01.26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A703EACA-297E-4DAF-8056-15AF1B3A9F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D44388DE-459A-41E9-9C88-711D58237E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ADA1EA-E962-4660-8069-EE334EA8302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702525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8DB2F8B-1FDF-4B40-B1A1-0217C840C9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093DE68F-19FC-44D5-B2E4-F9AB82B765D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5C2FD30D-2832-49D9-8A65-D223AAB2DB7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176AB268-44A5-4F30-8A7C-F835F0C354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F20D84-A121-4D68-964B-4CEB1B9137B6}" type="datetimeFigureOut">
              <a:rPr lang="de-DE" smtClean="0"/>
              <a:t>14.01.26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0FBF0B95-12FE-415C-92CE-8D58BCDBD0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EF0BB25A-CA41-406B-B064-8AB3AA91AF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ADA1EA-E962-4660-8069-EE334EA8302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997360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DE02A2B-493E-48F9-AF0E-560555C3F9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33DB5109-397C-485E-8719-3DC4B4F176B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9722B394-2241-41A2-A3B1-FE443C2BBB8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18444761-9056-4E74-9EEF-13E1737448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F20D84-A121-4D68-964B-4CEB1B9137B6}" type="datetimeFigureOut">
              <a:rPr lang="de-DE" smtClean="0"/>
              <a:t>14.01.26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ADD31BB1-965D-41B7-B1AA-F0D9E9607B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BA947818-8C3A-4AC4-A0D1-FFF83D0FC2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ADA1EA-E962-4660-8069-EE334EA8302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91560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390A03C7-9CB3-43EC-9869-FFED21556E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0DB03530-046F-449B-B1FE-A6887ECF530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94FDF0D5-6099-4FCD-9F3D-B9EC32AECE2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F20D84-A121-4D68-964B-4CEB1B9137B6}" type="datetimeFigureOut">
              <a:rPr lang="de-DE" smtClean="0"/>
              <a:t>14.01.26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0161D166-806F-4A10-9EC3-64999F5E363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BCC40F5F-87BF-4285-9E23-128C7AB41F4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ADA1EA-E962-4660-8069-EE334EA8302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397960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elle 3">
            <a:extLst>
              <a:ext uri="{FF2B5EF4-FFF2-40B4-BE49-F238E27FC236}">
                <a16:creationId xmlns:a16="http://schemas.microsoft.com/office/drawing/2014/main" id="{4944CCFA-BB97-43F0-A3A6-DAD025C8BBB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00970183"/>
              </p:ext>
            </p:extLst>
          </p:nvPr>
        </p:nvGraphicFramePr>
        <p:xfrm>
          <a:off x="2370183" y="385192"/>
          <a:ext cx="7451634" cy="5965696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709333">
                  <a:extLst>
                    <a:ext uri="{9D8B030D-6E8A-4147-A177-3AD203B41FA5}">
                      <a16:colId xmlns:a16="http://schemas.microsoft.com/office/drawing/2014/main" val="4187283027"/>
                    </a:ext>
                  </a:extLst>
                </a:gridCol>
                <a:gridCol w="2092867">
                  <a:extLst>
                    <a:ext uri="{9D8B030D-6E8A-4147-A177-3AD203B41FA5}">
                      <a16:colId xmlns:a16="http://schemas.microsoft.com/office/drawing/2014/main" val="3323022477"/>
                    </a:ext>
                  </a:extLst>
                </a:gridCol>
                <a:gridCol w="2649434">
                  <a:extLst>
                    <a:ext uri="{9D8B030D-6E8A-4147-A177-3AD203B41FA5}">
                      <a16:colId xmlns:a16="http://schemas.microsoft.com/office/drawing/2014/main" val="3842274455"/>
                    </a:ext>
                  </a:extLst>
                </a:gridCol>
              </a:tblGrid>
              <a:tr h="138794">
                <a:tc>
                  <a:txBody>
                    <a:bodyPr/>
                    <a:lstStyle/>
                    <a:p>
                      <a:r>
                        <a:rPr lang="de-DE" sz="1400" b="1" dirty="0"/>
                        <a:t>Region</a:t>
                      </a: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1400" b="1" dirty="0"/>
                        <a:t>Country</a:t>
                      </a: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1400" b="1" dirty="0" err="1"/>
                        <a:t>Number</a:t>
                      </a:r>
                      <a:r>
                        <a:rPr lang="de-DE" sz="1400" b="1" dirty="0"/>
                        <a:t> </a:t>
                      </a:r>
                      <a:r>
                        <a:rPr lang="de-DE" sz="1400" b="1" dirty="0" err="1"/>
                        <a:t>of</a:t>
                      </a:r>
                      <a:r>
                        <a:rPr lang="de-DE" sz="1400" b="1" dirty="0"/>
                        <a:t> </a:t>
                      </a:r>
                      <a:r>
                        <a:rPr lang="de-DE" sz="1400" b="1" dirty="0" err="1"/>
                        <a:t>respondents</a:t>
                      </a:r>
                      <a:endParaRPr lang="de-DE" sz="1400" b="1" dirty="0"/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48667679"/>
                  </a:ext>
                </a:extLst>
              </a:tr>
              <a:tr h="233165">
                <a:tc>
                  <a:txBody>
                    <a:bodyPr/>
                    <a:lstStyle/>
                    <a:p>
                      <a:r>
                        <a:rPr lang="de-DE" sz="1400" b="1" dirty="0"/>
                        <a:t>Europ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de-DE" sz="1400" b="0" dirty="0" err="1"/>
                        <a:t>Bulgaria</a:t>
                      </a:r>
                      <a:endParaRPr lang="de-DE" sz="1400" b="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94366711"/>
                  </a:ext>
                </a:extLst>
              </a:tr>
              <a:tr h="329728">
                <a:tc>
                  <a:txBody>
                    <a:bodyPr/>
                    <a:lstStyle/>
                    <a:p>
                      <a:endParaRPr lang="de-DE" sz="1400" b="1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400" dirty="0" err="1"/>
                        <a:t>Denmark</a:t>
                      </a:r>
                      <a:endParaRPr lang="de-DE" sz="14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400" dirty="0"/>
                        <a:t>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26696726"/>
                  </a:ext>
                </a:extLst>
              </a:tr>
              <a:tr h="329728">
                <a:tc>
                  <a:txBody>
                    <a:bodyPr/>
                    <a:lstStyle/>
                    <a:p>
                      <a:endParaRPr lang="de-DE" sz="1400" b="1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400" dirty="0"/>
                        <a:t>Germany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400" dirty="0"/>
                        <a:t>3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15131511"/>
                  </a:ext>
                </a:extLst>
              </a:tr>
              <a:tr h="329728">
                <a:tc>
                  <a:txBody>
                    <a:bodyPr/>
                    <a:lstStyle/>
                    <a:p>
                      <a:endParaRPr lang="de-DE" sz="1400" b="1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400" dirty="0" err="1"/>
                        <a:t>Italy</a:t>
                      </a:r>
                      <a:r>
                        <a:rPr lang="de-DE" sz="1400" dirty="0"/>
                        <a:t> 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400" dirty="0"/>
                        <a:t>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5474470"/>
                  </a:ext>
                </a:extLst>
              </a:tr>
              <a:tr h="329728">
                <a:tc>
                  <a:txBody>
                    <a:bodyPr/>
                    <a:lstStyle/>
                    <a:p>
                      <a:endParaRPr lang="de-DE" sz="1400" b="1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400" dirty="0" err="1"/>
                        <a:t>Latvia</a:t>
                      </a:r>
                      <a:r>
                        <a:rPr lang="de-DE" sz="1400" dirty="0"/>
                        <a:t> 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400" dirty="0"/>
                        <a:t>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95951444"/>
                  </a:ext>
                </a:extLst>
              </a:tr>
              <a:tr h="329728">
                <a:tc>
                  <a:txBody>
                    <a:bodyPr/>
                    <a:lstStyle/>
                    <a:p>
                      <a:endParaRPr lang="de-DE" sz="1400" b="1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400" dirty="0" err="1"/>
                        <a:t>Netherlands</a:t>
                      </a:r>
                      <a:r>
                        <a:rPr lang="de-DE" sz="1400" dirty="0"/>
                        <a:t> 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400" dirty="0"/>
                        <a:t>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06577101"/>
                  </a:ext>
                </a:extLst>
              </a:tr>
              <a:tr h="329728">
                <a:tc>
                  <a:txBody>
                    <a:bodyPr/>
                    <a:lstStyle/>
                    <a:p>
                      <a:endParaRPr lang="de-DE" sz="1400" b="1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400" dirty="0"/>
                        <a:t>North </a:t>
                      </a:r>
                      <a:r>
                        <a:rPr lang="de-DE" sz="1400" dirty="0" err="1"/>
                        <a:t>Macedonia</a:t>
                      </a:r>
                      <a:endParaRPr lang="de-DE" sz="14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400" dirty="0"/>
                        <a:t>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28167473"/>
                  </a:ext>
                </a:extLst>
              </a:tr>
              <a:tr h="329728">
                <a:tc>
                  <a:txBody>
                    <a:bodyPr/>
                    <a:lstStyle/>
                    <a:p>
                      <a:endParaRPr lang="de-DE" sz="1400" b="1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400" dirty="0"/>
                        <a:t>Austria 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400" dirty="0"/>
                        <a:t>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54424210"/>
                  </a:ext>
                </a:extLst>
              </a:tr>
              <a:tr h="130086">
                <a:tc>
                  <a:txBody>
                    <a:bodyPr/>
                    <a:lstStyle/>
                    <a:p>
                      <a:endParaRPr lang="de-DE" sz="1400" b="1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400" dirty="0" err="1"/>
                        <a:t>Poland</a:t>
                      </a:r>
                      <a:r>
                        <a:rPr lang="de-DE" sz="1400" dirty="0"/>
                        <a:t> 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400" dirty="0"/>
                        <a:t>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91705247"/>
                  </a:ext>
                </a:extLst>
              </a:tr>
              <a:tr h="0">
                <a:tc>
                  <a:txBody>
                    <a:bodyPr/>
                    <a:lstStyle/>
                    <a:p>
                      <a:endParaRPr lang="de-DE" sz="1400" b="1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400" dirty="0"/>
                        <a:t>Czech </a:t>
                      </a:r>
                      <a:r>
                        <a:rPr lang="de-DE" sz="1400" dirty="0" err="1"/>
                        <a:t>Republic</a:t>
                      </a:r>
                      <a:endParaRPr lang="de-DE" sz="1400" b="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400" dirty="0"/>
                        <a:t>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78239605"/>
                  </a:ext>
                </a:extLst>
              </a:tr>
              <a:tr h="193958">
                <a:tc>
                  <a:txBody>
                    <a:bodyPr/>
                    <a:lstStyle/>
                    <a:p>
                      <a:r>
                        <a:rPr lang="de-DE" sz="1400" b="1" dirty="0"/>
                        <a:t>South </a:t>
                      </a:r>
                      <a:r>
                        <a:rPr lang="de-DE" sz="1400" b="1" dirty="0" err="1"/>
                        <a:t>America</a:t>
                      </a:r>
                      <a:endParaRPr lang="de-DE" sz="1400" b="1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Argentina</a:t>
                      </a:r>
                      <a:endParaRPr lang="de-DE" sz="1400" b="0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1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868769159"/>
                  </a:ext>
                </a:extLst>
              </a:tr>
              <a:tr h="193958">
                <a:tc>
                  <a:txBody>
                    <a:bodyPr/>
                    <a:lstStyle/>
                    <a:p>
                      <a:endParaRPr lang="de-DE" sz="1400" b="1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Brazil</a:t>
                      </a:r>
                      <a:endParaRPr lang="de-DE" sz="1400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1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748280780"/>
                  </a:ext>
                </a:extLst>
              </a:tr>
              <a:tr h="193958">
                <a:tc>
                  <a:txBody>
                    <a:bodyPr/>
                    <a:lstStyle/>
                    <a:p>
                      <a:endParaRPr lang="de-DE" sz="1400" b="1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Ecuador</a:t>
                      </a:r>
                      <a:endParaRPr lang="de-DE" sz="1400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1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773900200"/>
                  </a:ext>
                </a:extLst>
              </a:tr>
              <a:tr h="193958">
                <a:tc>
                  <a:txBody>
                    <a:bodyPr/>
                    <a:lstStyle/>
                    <a:p>
                      <a:endParaRPr lang="de-DE" sz="1400" b="1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Peru</a:t>
                      </a:r>
                      <a:endParaRPr lang="de-DE" sz="1400" b="0" dirty="0"/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1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45292745"/>
                  </a:ext>
                </a:extLst>
              </a:tr>
              <a:tr h="193958">
                <a:tc>
                  <a:txBody>
                    <a:bodyPr/>
                    <a:lstStyle/>
                    <a:p>
                      <a:r>
                        <a:rPr lang="de-DE" sz="1400" b="1" dirty="0"/>
                        <a:t>North </a:t>
                      </a:r>
                      <a:r>
                        <a:rPr lang="de-DE" sz="1400" b="1" dirty="0" err="1"/>
                        <a:t>America</a:t>
                      </a:r>
                      <a:endParaRPr lang="de-DE" sz="1400" b="1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United States </a:t>
                      </a:r>
                      <a:r>
                        <a:rPr lang="de-DE" sz="1400" dirty="0" err="1"/>
                        <a:t>of</a:t>
                      </a:r>
                      <a:r>
                        <a:rPr lang="de-DE" sz="1400" dirty="0"/>
                        <a:t> </a:t>
                      </a:r>
                      <a:r>
                        <a:rPr lang="de-DE" sz="1400" dirty="0" err="1"/>
                        <a:t>America</a:t>
                      </a:r>
                      <a:endParaRPr lang="de-DE" sz="1400" b="0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1</a:t>
                      </a: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057552381"/>
                  </a:ext>
                </a:extLst>
              </a:tr>
              <a:tr h="193958">
                <a:tc>
                  <a:txBody>
                    <a:bodyPr/>
                    <a:lstStyle/>
                    <a:p>
                      <a:r>
                        <a:rPr lang="de-DE" sz="1400" b="1" dirty="0"/>
                        <a:t>Asi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United </a:t>
                      </a:r>
                      <a:r>
                        <a:rPr lang="de-DE" sz="1400" dirty="0" err="1"/>
                        <a:t>Arab</a:t>
                      </a:r>
                      <a:r>
                        <a:rPr lang="de-DE" sz="1400" dirty="0"/>
                        <a:t> Emirates</a:t>
                      </a:r>
                      <a:endParaRPr lang="de-DE" sz="1400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8072881"/>
                  </a:ext>
                </a:extLst>
              </a:tr>
              <a:tr h="193958">
                <a:tc>
                  <a:txBody>
                    <a:bodyPr/>
                    <a:lstStyle/>
                    <a:p>
                      <a:endParaRPr lang="de-DE" sz="14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Thailand</a:t>
                      </a:r>
                      <a:endParaRPr lang="de-DE" sz="1400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13796273"/>
                  </a:ext>
                </a:extLst>
              </a:tr>
              <a:tr h="193958">
                <a:tc>
                  <a:txBody>
                    <a:bodyPr/>
                    <a:lstStyle/>
                    <a:p>
                      <a:r>
                        <a:rPr lang="de-DE" sz="1400" b="1" dirty="0" err="1"/>
                        <a:t>Oceania</a:t>
                      </a:r>
                      <a:endParaRPr lang="de-DE" sz="14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New Zealand</a:t>
                      </a:r>
                      <a:endParaRPr lang="de-DE" sz="1400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6328739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2789822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E4A34C7845C88B4589819AB139DE35DD" ma:contentTypeVersion="17" ma:contentTypeDescription="Create a new document." ma:contentTypeScope="" ma:versionID="b73a15a856e980d49a532457ee2e71fc">
  <xsd:schema xmlns:xsd="http://www.w3.org/2001/XMLSchema" xmlns:xs="http://www.w3.org/2001/XMLSchema" xmlns:p="http://schemas.microsoft.com/office/2006/metadata/properties" xmlns:ns3="d0d5103c-b90a-4a38-b610-628dbca45d0e" xmlns:ns4="63bc265c-ce59-4c31-a2a5-336a7fcf9d48" targetNamespace="http://schemas.microsoft.com/office/2006/metadata/properties" ma:root="true" ma:fieldsID="d739dc78d0f205514dd0f8cf53e80a74" ns3:_="" ns4:_="">
    <xsd:import namespace="d0d5103c-b90a-4a38-b610-628dbca45d0e"/>
    <xsd:import namespace="63bc265c-ce59-4c31-a2a5-336a7fcf9d48"/>
    <xsd:element name="properties">
      <xsd:complexType>
        <xsd:sequence>
          <xsd:element name="documentManagement">
            <xsd:complexType>
              <xsd:all>
                <xsd:element ref="ns3:_activity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Metadata" minOccurs="0"/>
                <xsd:element ref="ns3:MediaServiceFastMetadata" minOccurs="0"/>
                <xsd:element ref="ns3:MediaServiceDateTaken" minOccurs="0"/>
                <xsd:element ref="ns3:MediaServiceAutoTags" minOccurs="0"/>
                <xsd:element ref="ns3:MediaLengthInSeconds" minOccurs="0"/>
                <xsd:element ref="ns3:MediaServiceObjectDetectorVersions" minOccurs="0"/>
                <xsd:element ref="ns3:MediaServiceSearchProperties" minOccurs="0"/>
                <xsd:element ref="ns3:MediaServiceSystemTags" minOccurs="0"/>
                <xsd:element ref="ns3:MediaServiceLocation" minOccurs="0"/>
                <xsd:element ref="ns3:MediaServiceGenerationTime" minOccurs="0"/>
                <xsd:element ref="ns3:MediaServiceEventHashCode" minOccurs="0"/>
                <xsd:element ref="ns3:MediaServiceOCR" minOccurs="0"/>
                <xsd:element ref="ns3:MediaServiceBillingMetadata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d0d5103c-b90a-4a38-b610-628dbca45d0e" elementFormDefault="qualified">
    <xsd:import namespace="http://schemas.microsoft.com/office/2006/documentManagement/types"/>
    <xsd:import namespace="http://schemas.microsoft.com/office/infopath/2007/PartnerControls"/>
    <xsd:element name="_activity" ma:index="8" nillable="true" ma:displayName="_activity" ma:hidden="true" ma:internalName="_activity">
      <xsd:simpleType>
        <xsd:restriction base="dms:Note"/>
      </xsd:simpleType>
    </xsd:element>
    <xsd:element name="MediaServiceMetadata" ma:index="12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13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4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ServiceAutoTags" ma:index="15" nillable="true" ma:displayName="Tags" ma:internalName="MediaServiceAutoTags" ma:readOnly="true">
      <xsd:simpleType>
        <xsd:restriction base="dms:Text"/>
      </xsd:simpleType>
    </xsd:element>
    <xsd:element name="MediaLengthInSeconds" ma:index="16" nillable="true" ma:displayName="MediaLengthInSeconds" ma:hidden="true" ma:internalName="MediaLengthInSeconds" ma:readOnly="true">
      <xsd:simpleType>
        <xsd:restriction base="dms:Unknown"/>
      </xsd:simpleType>
    </xsd:element>
    <xsd:element name="MediaServiceObjectDetectorVersions" ma:index="17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18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SystemTags" ma:index="19" nillable="true" ma:displayName="MediaServiceSystemTags" ma:hidden="true" ma:internalName="MediaServiceSystemTags" ma:readOnly="true">
      <xsd:simpleType>
        <xsd:restriction base="dms:Note"/>
      </xsd:simpleType>
    </xsd:element>
    <xsd:element name="MediaServiceLocation" ma:index="20" nillable="true" ma:displayName="Location" ma:indexed="true" ma:internalName="MediaServiceLocation" ma:readOnly="true">
      <xsd:simpleType>
        <xsd:restriction base="dms:Text"/>
      </xsd:simpleType>
    </xsd:element>
    <xsd:element name="MediaServiceGenerationTime" ma:index="21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22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23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BillingMetadata" ma:index="24" nillable="true" ma:displayName="MediaServiceBillingMetadata" ma:hidden="true" ma:internalName="MediaServiceBillingMetadata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63bc265c-ce59-4c31-a2a5-336a7fcf9d48" elementFormDefault="qualified">
    <xsd:import namespace="http://schemas.microsoft.com/office/2006/documentManagement/types"/>
    <xsd:import namespace="http://schemas.microsoft.com/office/infopath/2007/PartnerControls"/>
    <xsd:element name="SharedWithUsers" ma:index="9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0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1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d0d5103c-b90a-4a38-b610-628dbca45d0e" xsi:nil="true"/>
  </documentManagement>
</p:properties>
</file>

<file path=customXml/itemProps1.xml><?xml version="1.0" encoding="utf-8"?>
<ds:datastoreItem xmlns:ds="http://schemas.openxmlformats.org/officeDocument/2006/customXml" ds:itemID="{4310EDBE-5F35-4C6D-BF59-32027223946A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d0d5103c-b90a-4a38-b610-628dbca45d0e"/>
    <ds:schemaRef ds:uri="63bc265c-ce59-4c31-a2a5-336a7fcf9d48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D60F6187-6EF2-4B2E-BB74-0D60E5A277D0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4B26B28E-BFEC-469A-B0BA-304C6859BE63}">
  <ds:schemaRefs>
    <ds:schemaRef ds:uri="http://schemas.openxmlformats.org/package/2006/metadata/core-properties"/>
    <ds:schemaRef ds:uri="http://schemas.microsoft.com/office/2006/documentManagement/types"/>
    <ds:schemaRef ds:uri="http://purl.org/dc/elements/1.1/"/>
    <ds:schemaRef ds:uri="http://purl.org/dc/dcmitype/"/>
    <ds:schemaRef ds:uri="http://www.w3.org/XML/1998/namespace"/>
    <ds:schemaRef ds:uri="http://purl.org/dc/terms/"/>
    <ds:schemaRef ds:uri="63bc265c-ce59-4c31-a2a5-336a7fcf9d48"/>
    <ds:schemaRef ds:uri="d0d5103c-b90a-4a38-b610-628dbca45d0e"/>
    <ds:schemaRef ds:uri="http://schemas.microsoft.com/office/infopath/2007/PartnerControls"/>
    <ds:schemaRef ds:uri="http://schemas.microsoft.com/office/2006/metadata/propertie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6</Words>
  <Application>Microsoft Macintosh PowerPoint</Application>
  <PresentationFormat>Breitbild</PresentationFormat>
  <Paragraphs>44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Buttgereit, Thomas</dc:creator>
  <cp:lastModifiedBy>Buttgereit, Thomas</cp:lastModifiedBy>
  <cp:revision>2</cp:revision>
  <dcterms:created xsi:type="dcterms:W3CDTF">2026-01-06T15:32:01Z</dcterms:created>
  <dcterms:modified xsi:type="dcterms:W3CDTF">2026-01-14T18:35:0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E4A34C7845C88B4589819AB139DE35DD</vt:lpwstr>
  </property>
</Properties>
</file>